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6" r:id="rId3"/>
    <p:sldId id="258" r:id="rId4"/>
    <p:sldId id="257" r:id="rId5"/>
    <p:sldId id="259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10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105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709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080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381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55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727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099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884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878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75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BEEE9-9B1B-4EFA-BCF9-94F5064D3408}" type="datetimeFigureOut">
              <a:rPr lang="en-US" smtClean="0"/>
              <a:t>11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464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hyperlink" Target="https://github.com/alexmaltsev/IterativeNetworkGenerator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>
            <a:extLst>
              <a:ext uri="{FF2B5EF4-FFF2-40B4-BE49-F238E27FC236}">
                <a16:creationId xmlns:a16="http://schemas.microsoft.com/office/drawing/2014/main" id="{9D547465-769F-8307-3306-C8127BBC8211}"/>
              </a:ext>
            </a:extLst>
          </p:cNvPr>
          <p:cNvSpPr txBox="1"/>
          <p:nvPr/>
        </p:nvSpPr>
        <p:spPr>
          <a:xfrm>
            <a:off x="3637325" y="602188"/>
            <a:ext cx="5323795" cy="41354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5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 Our novel algorithm to generate modular SAN network.</a:t>
            </a:r>
            <a:r>
              <a:rPr lang="en-US" sz="105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algorithm starts with a set of separated nodes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um_nodes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 500). It generates a probability density function (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df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determining the connection probability of each node (Panel A). It has a saw shape. Each sawtooth (we call it "tent" in the code commentaries) represents a module. The node at its peak signifies the module's attractor or hub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L),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ecause this node and its neighbors have higher probability of establishing connections with other nodes. Then for each node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from 1 to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um_nodes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rogram finds the target node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j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connects them if possible. This is achieved by calling 3 times a random number generator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p.random.choice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hown figuratively by a flip coin in panel B as follows: 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) Test if the target node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j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will be searched within the module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_in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0.95)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r outside the module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_out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0.05).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ifferent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_in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nd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_out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determine modular structure of the network, i.e. loosely connected (via low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_out</a:t>
            </a:r>
            <a:r>
              <a:rPr lang="en-US" sz="1050" dirty="0">
                <a:latin typeface="Times New Roman" panose="02020603050405020304" pitchFamily="18" charset="0"/>
                <a:ea typeface="Calibri" panose="020F0502020204030204" pitchFamily="34" charset="0"/>
              </a:rPr>
              <a:t>) modules of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ightly connected (via high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_in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of cells.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) Find the target node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j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based on the respective probability density function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df_inner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r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df_outer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hese reduced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df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 are created from the full-range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df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 panel A by excluding nodes outside or inside the module (respectively) and renormalizing the resultant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df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) Test if the number of established connections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.degree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j)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 the target node 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j 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oes not exceed a maximum number of connections that vary from 2 to 5, depending on the result of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p.random.choice</a:t>
            </a: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all. The respective probabilities p=[0.5, 0.25, 0.125, 0.125] for the call were found empirically to generate a cellular network with reasonable connectivity (Fig.1B in main text).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otes: 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) Because establishing connections is a probabilistic process, it is possible that some nodes remain separated, so that the final number of nodes can be less than 500. 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5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) Visualizations were performed by a Python library </a:t>
            </a:r>
            <a:r>
              <a:rPr lang="en-US" sz="105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lotly</a:t>
            </a:r>
            <a:r>
              <a:rPr lang="en-US" sz="10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>
              <a:lnSpc>
                <a:spcPct val="107000"/>
              </a:lnSpc>
            </a:pPr>
            <a:endParaRPr lang="en-US" sz="105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0A1EBC3-C0C7-B796-7B29-10AD5429FDD3}"/>
              </a:ext>
            </a:extLst>
          </p:cNvPr>
          <p:cNvSpPr/>
          <p:nvPr/>
        </p:nvSpPr>
        <p:spPr>
          <a:xfrm>
            <a:off x="317447" y="4999992"/>
            <a:ext cx="371476" cy="2728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CA8D96DF-DB43-7010-FA44-A0E6478DFA15}"/>
              </a:ext>
            </a:extLst>
          </p:cNvPr>
          <p:cNvSpPr/>
          <p:nvPr/>
        </p:nvSpPr>
        <p:spPr>
          <a:xfrm>
            <a:off x="4716168" y="5427131"/>
            <a:ext cx="497417" cy="3139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8B13C61A-473F-A125-99B7-C4DBFDA465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75519" y="5294332"/>
            <a:ext cx="441351" cy="395240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1A0B21B0-0D44-CA6D-92DA-0B890E0A5D33}"/>
              </a:ext>
            </a:extLst>
          </p:cNvPr>
          <p:cNvSpPr txBox="1"/>
          <p:nvPr/>
        </p:nvSpPr>
        <p:spPr>
          <a:xfrm rot="19195750">
            <a:off x="5389048" y="4909559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(2)= 0.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3C081BD-15B1-DB0D-36EA-FF160A8EFB76}"/>
              </a:ext>
            </a:extLst>
          </p:cNvPr>
          <p:cNvSpPr txBox="1"/>
          <p:nvPr/>
        </p:nvSpPr>
        <p:spPr>
          <a:xfrm rot="20910043">
            <a:off x="5535509" y="5164898"/>
            <a:ext cx="7601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(3)=0.25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07009B85-904D-A500-A659-AB86D7CF4612}"/>
              </a:ext>
            </a:extLst>
          </p:cNvPr>
          <p:cNvSpPr/>
          <p:nvPr/>
        </p:nvSpPr>
        <p:spPr>
          <a:xfrm>
            <a:off x="5836471" y="5707580"/>
            <a:ext cx="304136" cy="143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5C44CFB-1ED5-D39C-7A57-54BF7C8148C7}"/>
              </a:ext>
            </a:extLst>
          </p:cNvPr>
          <p:cNvSpPr txBox="1"/>
          <p:nvPr/>
        </p:nvSpPr>
        <p:spPr>
          <a:xfrm>
            <a:off x="6182839" y="4636574"/>
            <a:ext cx="25744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.degree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j) &lt; 2, connect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j 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2ADC562-EA43-19FB-217F-D158F1B00899}"/>
              </a:ext>
            </a:extLst>
          </p:cNvPr>
          <p:cNvSpPr txBox="1"/>
          <p:nvPr/>
        </p:nvSpPr>
        <p:spPr>
          <a:xfrm rot="2379547">
            <a:off x="5671967" y="5860272"/>
            <a:ext cx="8306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(5)=0.125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C31AE39-D240-055C-E2BC-352440471295}"/>
              </a:ext>
            </a:extLst>
          </p:cNvPr>
          <p:cNvSpPr txBox="1"/>
          <p:nvPr/>
        </p:nvSpPr>
        <p:spPr>
          <a:xfrm rot="907869">
            <a:off x="5588262" y="5496072"/>
            <a:ext cx="8306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(4)=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25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D9345477-EE16-670C-121A-2599F25C2E30}"/>
              </a:ext>
            </a:extLst>
          </p:cNvPr>
          <p:cNvCxnSpPr>
            <a:cxnSpLocks/>
          </p:cNvCxnSpPr>
          <p:nvPr/>
        </p:nvCxnSpPr>
        <p:spPr>
          <a:xfrm flipV="1">
            <a:off x="5334444" y="4790463"/>
            <a:ext cx="894906" cy="74288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E122DFDD-5A9D-9BD1-5ADC-A37930922788}"/>
              </a:ext>
            </a:extLst>
          </p:cNvPr>
          <p:cNvCxnSpPr>
            <a:cxnSpLocks/>
          </p:cNvCxnSpPr>
          <p:nvPr/>
        </p:nvCxnSpPr>
        <p:spPr>
          <a:xfrm flipV="1">
            <a:off x="5334444" y="5329181"/>
            <a:ext cx="935803" cy="21435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5C7A6094-C98A-7AC5-3FC9-37D149956282}"/>
              </a:ext>
            </a:extLst>
          </p:cNvPr>
          <p:cNvCxnSpPr>
            <a:cxnSpLocks/>
          </p:cNvCxnSpPr>
          <p:nvPr/>
        </p:nvCxnSpPr>
        <p:spPr>
          <a:xfrm>
            <a:off x="5327564" y="5532385"/>
            <a:ext cx="942683" cy="29588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CB3726C4-E5EA-ED61-455C-7B8E39635B0E}"/>
              </a:ext>
            </a:extLst>
          </p:cNvPr>
          <p:cNvCxnSpPr>
            <a:cxnSpLocks/>
          </p:cNvCxnSpPr>
          <p:nvPr/>
        </p:nvCxnSpPr>
        <p:spPr>
          <a:xfrm>
            <a:off x="5324279" y="5543536"/>
            <a:ext cx="959566" cy="76423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 65">
            <a:extLst>
              <a:ext uri="{FF2B5EF4-FFF2-40B4-BE49-F238E27FC236}">
                <a16:creationId xmlns:a16="http://schemas.microsoft.com/office/drawing/2014/main" id="{12B2CB45-976C-8DED-F394-E7B98B1D38A4}"/>
              </a:ext>
            </a:extLst>
          </p:cNvPr>
          <p:cNvSpPr/>
          <p:nvPr/>
        </p:nvSpPr>
        <p:spPr>
          <a:xfrm>
            <a:off x="1366782" y="6322255"/>
            <a:ext cx="500063" cy="1476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D4DDE3E-9980-55FB-E210-26ED89C3AD3B}"/>
              </a:ext>
            </a:extLst>
          </p:cNvPr>
          <p:cNvSpPr txBox="1"/>
          <p:nvPr/>
        </p:nvSpPr>
        <p:spPr>
          <a:xfrm>
            <a:off x="3581672" y="4728640"/>
            <a:ext cx="147933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ds node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side module M</a:t>
            </a:r>
            <a:endParaRPr 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3" name="Picture 72">
            <a:extLst>
              <a:ext uri="{FF2B5EF4-FFF2-40B4-BE49-F238E27FC236}">
                <a16:creationId xmlns:a16="http://schemas.microsoft.com/office/drawing/2014/main" id="{D2EB193D-97DD-5863-EB5F-0F278A29D6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1125" y="5166204"/>
            <a:ext cx="441351" cy="395240"/>
          </a:xfrm>
          <a:prstGeom prst="rect">
            <a:avLst/>
          </a:prstGeom>
        </p:spPr>
      </p:pic>
      <p:sp>
        <p:nvSpPr>
          <p:cNvPr id="74" name="TextBox 73">
            <a:extLst>
              <a:ext uri="{FF2B5EF4-FFF2-40B4-BE49-F238E27FC236}">
                <a16:creationId xmlns:a16="http://schemas.microsoft.com/office/drawing/2014/main" id="{FABF83BA-A305-C4BB-EE07-F6F53D2A7673}"/>
              </a:ext>
            </a:extLst>
          </p:cNvPr>
          <p:cNvSpPr txBox="1"/>
          <p:nvPr/>
        </p:nvSpPr>
        <p:spPr>
          <a:xfrm>
            <a:off x="551712" y="4934029"/>
            <a:ext cx="11384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p.random.choice</a:t>
            </a:r>
            <a:endParaRPr lang="en-US" sz="1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CA1395CD-1F2D-D4AF-48CA-992FD6786423}"/>
              </a:ext>
            </a:extLst>
          </p:cNvPr>
          <p:cNvCxnSpPr>
            <a:cxnSpLocks/>
          </p:cNvCxnSpPr>
          <p:nvPr/>
        </p:nvCxnSpPr>
        <p:spPr>
          <a:xfrm flipV="1">
            <a:off x="1428929" y="5032904"/>
            <a:ext cx="945495" cy="49948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A6336162-140A-BEE3-23A1-92A6A4E52831}"/>
              </a:ext>
            </a:extLst>
          </p:cNvPr>
          <p:cNvCxnSpPr>
            <a:cxnSpLocks/>
          </p:cNvCxnSpPr>
          <p:nvPr/>
        </p:nvCxnSpPr>
        <p:spPr>
          <a:xfrm>
            <a:off x="1422049" y="5532385"/>
            <a:ext cx="971761" cy="5371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2274B90F-D8DC-BA03-7FCD-39D2767A6DB8}"/>
              </a:ext>
            </a:extLst>
          </p:cNvPr>
          <p:cNvSpPr txBox="1"/>
          <p:nvPr/>
        </p:nvSpPr>
        <p:spPr>
          <a:xfrm rot="19968537">
            <a:off x="1489554" y="5031252"/>
            <a:ext cx="7761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_in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9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E634212D-4B59-9190-838B-CEC9933CF8CB}"/>
              </a:ext>
            </a:extLst>
          </p:cNvPr>
          <p:cNvSpPr txBox="1"/>
          <p:nvPr/>
        </p:nvSpPr>
        <p:spPr>
          <a:xfrm rot="1760926">
            <a:off x="1627700" y="5610298"/>
            <a:ext cx="8467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_out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5</a:t>
            </a:r>
          </a:p>
        </p:txBody>
      </p:sp>
      <p:pic>
        <p:nvPicPr>
          <p:cNvPr id="79" name="Picture 78">
            <a:extLst>
              <a:ext uri="{FF2B5EF4-FFF2-40B4-BE49-F238E27FC236}">
                <a16:creationId xmlns:a16="http://schemas.microsoft.com/office/drawing/2014/main" id="{817FAB82-DECA-C580-B03D-5768FFD8245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660"/>
          <a:stretch/>
        </p:blipFill>
        <p:spPr>
          <a:xfrm>
            <a:off x="2367963" y="4761354"/>
            <a:ext cx="394307" cy="395240"/>
          </a:xfrm>
          <a:prstGeom prst="rect">
            <a:avLst/>
          </a:prstGeom>
        </p:spPr>
      </p:pic>
      <p:pic>
        <p:nvPicPr>
          <p:cNvPr id="80" name="Picture 79">
            <a:extLst>
              <a:ext uri="{FF2B5EF4-FFF2-40B4-BE49-F238E27FC236}">
                <a16:creationId xmlns:a16="http://schemas.microsoft.com/office/drawing/2014/main" id="{E5D14522-B26A-724A-323C-C8B6571F184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660"/>
          <a:stretch/>
        </p:blipFill>
        <p:spPr>
          <a:xfrm>
            <a:off x="2393810" y="5898530"/>
            <a:ext cx="394307" cy="395240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FAD60E57-49C0-F4AB-649D-41D7DDADDABE}"/>
              </a:ext>
            </a:extLst>
          </p:cNvPr>
          <p:cNvSpPr txBox="1"/>
          <p:nvPr/>
        </p:nvSpPr>
        <p:spPr>
          <a:xfrm rot="935795">
            <a:off x="2859980" y="4831364"/>
            <a:ext cx="7312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f_inner</a:t>
            </a:r>
            <a:endParaRPr lang="en-US" sz="11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12D442C7-0FAA-52E7-EE52-9298C0EB2DFC}"/>
              </a:ext>
            </a:extLst>
          </p:cNvPr>
          <p:cNvCxnSpPr>
            <a:cxnSpLocks/>
          </p:cNvCxnSpPr>
          <p:nvPr/>
        </p:nvCxnSpPr>
        <p:spPr>
          <a:xfrm>
            <a:off x="2775362" y="4969659"/>
            <a:ext cx="1889463" cy="52077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43B6D99F-6F70-E606-C2AE-57EA7B7EBB3C}"/>
              </a:ext>
            </a:extLst>
          </p:cNvPr>
          <p:cNvSpPr txBox="1"/>
          <p:nvPr/>
        </p:nvSpPr>
        <p:spPr>
          <a:xfrm rot="20702211">
            <a:off x="2924240" y="5755163"/>
            <a:ext cx="7312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f_outer</a:t>
            </a:r>
            <a:endParaRPr lang="en-US" sz="11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544DF097-ACDF-64BA-3C5D-EBAFA35DEE93}"/>
              </a:ext>
            </a:extLst>
          </p:cNvPr>
          <p:cNvCxnSpPr>
            <a:cxnSpLocks/>
          </p:cNvCxnSpPr>
          <p:nvPr/>
        </p:nvCxnSpPr>
        <p:spPr>
          <a:xfrm flipV="1">
            <a:off x="2803583" y="5604511"/>
            <a:ext cx="1861242" cy="54410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C94AFAE7-4A13-66E0-DF4C-1334F01E8C43}"/>
              </a:ext>
            </a:extLst>
          </p:cNvPr>
          <p:cNvSpPr txBox="1"/>
          <p:nvPr/>
        </p:nvSpPr>
        <p:spPr>
          <a:xfrm>
            <a:off x="384339" y="5535675"/>
            <a:ext cx="13795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a given </a:t>
            </a:r>
          </a:p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de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module M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ED5E0C3-05F7-60FC-229F-9CB310F1D15B}"/>
              </a:ext>
            </a:extLst>
          </p:cNvPr>
          <p:cNvSpPr txBox="1"/>
          <p:nvPr/>
        </p:nvSpPr>
        <p:spPr>
          <a:xfrm>
            <a:off x="3625432" y="5845137"/>
            <a:ext cx="147933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ds node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utside module M</a:t>
            </a:r>
            <a:endParaRPr 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49B595E-7ADC-AA4C-C297-2DF6850EA32C}"/>
              </a:ext>
            </a:extLst>
          </p:cNvPr>
          <p:cNvSpPr txBox="1"/>
          <p:nvPr/>
        </p:nvSpPr>
        <p:spPr>
          <a:xfrm>
            <a:off x="516735" y="424114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A35B6E28-0772-F79B-CFCD-AA695FABF22E}"/>
              </a:ext>
            </a:extLst>
          </p:cNvPr>
          <p:cNvSpPr txBox="1"/>
          <p:nvPr/>
        </p:nvSpPr>
        <p:spPr>
          <a:xfrm>
            <a:off x="392854" y="46708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01BF80D-0F21-A007-FDC8-A53846FFDD77}"/>
              </a:ext>
            </a:extLst>
          </p:cNvPr>
          <p:cNvSpPr txBox="1"/>
          <p:nvPr/>
        </p:nvSpPr>
        <p:spPr>
          <a:xfrm>
            <a:off x="6255355" y="5147970"/>
            <a:ext cx="2614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.degree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j) &lt; 3, connect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j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6F890AE-0008-146E-CA68-CD8264B8CC59}"/>
              </a:ext>
            </a:extLst>
          </p:cNvPr>
          <p:cNvSpPr txBox="1"/>
          <p:nvPr/>
        </p:nvSpPr>
        <p:spPr>
          <a:xfrm>
            <a:off x="6255355" y="5608542"/>
            <a:ext cx="2614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.degree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j) &lt; 4, connect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j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86DA43C-C31F-B5D4-472D-B855C758852F}"/>
              </a:ext>
            </a:extLst>
          </p:cNvPr>
          <p:cNvSpPr txBox="1"/>
          <p:nvPr/>
        </p:nvSpPr>
        <p:spPr>
          <a:xfrm>
            <a:off x="6255355" y="6139881"/>
            <a:ext cx="2614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.degree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j) &lt; 5, connect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j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BAFD803-9F30-C032-57B1-613A9276509A}"/>
              </a:ext>
            </a:extLst>
          </p:cNvPr>
          <p:cNvSpPr txBox="1"/>
          <p:nvPr/>
        </p:nvSpPr>
        <p:spPr>
          <a:xfrm>
            <a:off x="2133932" y="5384768"/>
            <a:ext cx="11384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p.random.choice</a:t>
            </a:r>
            <a:endParaRPr lang="en-US" sz="1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124A795-829C-07E0-43BA-B7316510CD7F}"/>
              </a:ext>
            </a:extLst>
          </p:cNvPr>
          <p:cNvSpPr txBox="1"/>
          <p:nvPr/>
        </p:nvSpPr>
        <p:spPr>
          <a:xfrm>
            <a:off x="4457872" y="5622394"/>
            <a:ext cx="11384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p.random.choice</a:t>
            </a:r>
            <a:endParaRPr lang="en-US" sz="1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35D083D-DC88-7144-AE36-255F7CDF4068}"/>
              </a:ext>
            </a:extLst>
          </p:cNvPr>
          <p:cNvSpPr txBox="1"/>
          <p:nvPr/>
        </p:nvSpPr>
        <p:spPr>
          <a:xfrm>
            <a:off x="86768" y="1672235"/>
            <a:ext cx="1479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f(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D16EA3C5-A8D2-EBB3-FB54-26EE619AEE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933" y="970806"/>
            <a:ext cx="2950240" cy="2018412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777F2FEA-5F90-FD8A-077A-2FCB753C6A85}"/>
              </a:ext>
            </a:extLst>
          </p:cNvPr>
          <p:cNvSpPr txBox="1"/>
          <p:nvPr/>
        </p:nvSpPr>
        <p:spPr>
          <a:xfrm>
            <a:off x="1004848" y="671804"/>
            <a:ext cx="1479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tract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(0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A33F13A-87EF-8E7B-4302-195CFD00552B}"/>
              </a:ext>
            </a:extLst>
          </p:cNvPr>
          <p:cNvSpPr txBox="1"/>
          <p:nvPr/>
        </p:nvSpPr>
        <p:spPr>
          <a:xfrm>
            <a:off x="2259818" y="671804"/>
            <a:ext cx="1479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tract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(1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40DABCF-F884-7564-97B6-5ADCCA9CDEAB}"/>
              </a:ext>
            </a:extLst>
          </p:cNvPr>
          <p:cNvSpPr txBox="1"/>
          <p:nvPr/>
        </p:nvSpPr>
        <p:spPr>
          <a:xfrm>
            <a:off x="1744515" y="2977057"/>
            <a:ext cx="1479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de index,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76893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EEA4696-B743-4942-B8C8-336AF31EF4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9319901"/>
              </p:ext>
            </p:extLst>
          </p:nvPr>
        </p:nvGraphicFramePr>
        <p:xfrm>
          <a:off x="5529263" y="92075"/>
          <a:ext cx="3943350" cy="1136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ackager Shell Object" showAsIcon="1" r:id="rId2" imgW="1882080" imgH="542160" progId="Package">
                  <p:embed/>
                </p:oleObj>
              </mc:Choice>
              <mc:Fallback>
                <p:oleObj name="Packager Shell Object" showAsIcon="1" r:id="rId2" imgW="1882080" imgH="542160" progId="Package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529263" y="92075"/>
                        <a:ext cx="3943350" cy="1136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F6BE3BF5-740C-6E60-507E-E5B44B46A013}"/>
              </a:ext>
            </a:extLst>
          </p:cNvPr>
          <p:cNvSpPr txBox="1"/>
          <p:nvPr/>
        </p:nvSpPr>
        <p:spPr>
          <a:xfrm>
            <a:off x="6507011" y="1609309"/>
            <a:ext cx="215618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Double click the icon for 3D rotation of the model by mouse in your default browser  </a:t>
            </a:r>
          </a:p>
        </p:txBody>
      </p:sp>
      <p:sp>
        <p:nvSpPr>
          <p:cNvPr id="3" name="Arrow: Down 2">
            <a:extLst>
              <a:ext uri="{FF2B5EF4-FFF2-40B4-BE49-F238E27FC236}">
                <a16:creationId xmlns:a16="http://schemas.microsoft.com/office/drawing/2014/main" id="{E35BFC81-2761-E7BB-3229-12E69EE06E20}"/>
              </a:ext>
            </a:extLst>
          </p:cNvPr>
          <p:cNvSpPr/>
          <p:nvPr/>
        </p:nvSpPr>
        <p:spPr>
          <a:xfrm flipV="1">
            <a:off x="7415120" y="1163833"/>
            <a:ext cx="169985" cy="4454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A4F6F27-A10C-91E1-16C9-7AE08E5BD020}"/>
              </a:ext>
            </a:extLst>
          </p:cNvPr>
          <p:cNvSpPr txBox="1"/>
          <p:nvPr/>
        </p:nvSpPr>
        <p:spPr>
          <a:xfrm>
            <a:off x="631723" y="5837287"/>
            <a:ext cx="814167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2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urther spatial details of our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odel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own in Fig. 1B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f the main text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By double-clicking the icon in right-top corner, the model can be explored interactively in a 3D viewer in a default web browser (Google Chrome, Firefox, MS Edge). The model consists of two loosely coupled clusters (modules) of tightly coupled cells: 242 cells i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R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red circles) and 243 cells i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R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blue circles)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1AB6E41-32F8-D41B-6F2E-6E1076E7743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636" t="2131" r="4141" b="1884"/>
          <a:stretch/>
        </p:blipFill>
        <p:spPr>
          <a:xfrm>
            <a:off x="1356360" y="132312"/>
            <a:ext cx="4370675" cy="577522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FDAEE74-AB37-3309-B7B5-0BA69F75470D}"/>
              </a:ext>
            </a:extLst>
          </p:cNvPr>
          <p:cNvSpPr txBox="1"/>
          <p:nvPr/>
        </p:nvSpPr>
        <p:spPr>
          <a:xfrm>
            <a:off x="1304895" y="189716"/>
            <a:ext cx="2666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igher rate module (</a:t>
            </a:r>
            <a:r>
              <a:rPr lang="en-US" dirty="0" err="1"/>
              <a:t>HRM</a:t>
            </a:r>
            <a:r>
              <a:rPr lang="en-US" dirty="0"/>
              <a:t>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337CB0-79CF-B21A-1DFC-3CBBE685B338}"/>
              </a:ext>
            </a:extLst>
          </p:cNvPr>
          <p:cNvSpPr txBox="1"/>
          <p:nvPr/>
        </p:nvSpPr>
        <p:spPr>
          <a:xfrm>
            <a:off x="4440208" y="5248691"/>
            <a:ext cx="2573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ower rate module (</a:t>
            </a:r>
            <a:r>
              <a:rPr lang="en-US" dirty="0" err="1"/>
              <a:t>LRM</a:t>
            </a:r>
            <a:r>
              <a:rPr lang="en-U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9446408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D130EBF-85A0-6505-895E-5C07188D86DC}"/>
              </a:ext>
            </a:extLst>
          </p:cNvPr>
          <p:cNvSpPr txBox="1"/>
          <p:nvPr/>
        </p:nvSpPr>
        <p:spPr>
          <a:xfrm>
            <a:off x="541421" y="3669790"/>
            <a:ext cx="803107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3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istograms  of average AP cycle length of each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ell in each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odule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R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orange bars and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R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blue bars) in each condition (basal state,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R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timulation, and </a:t>
            </a:r>
            <a:r>
              <a:rPr lang="el-GR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R stimulation. Note: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R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bar is missing in the center panel becaus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R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ceased firing APs during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h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stimulation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8B3C3F9-5B1A-8BA3-C7D6-D92C065A65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4574" y="323414"/>
            <a:ext cx="2819606" cy="239490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A4599D0-6758-DF15-3C31-3DF60726B1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600" y="323414"/>
            <a:ext cx="2819606" cy="240072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44139D1-A262-F48A-EF03-333BC5DEEE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5793" y="323414"/>
            <a:ext cx="2819607" cy="24212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03422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06D4C8A-AE6E-729F-06CE-A4652F1CA8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2104" y="782131"/>
            <a:ext cx="2759222" cy="439152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930C6BD-3635-D1C8-B05C-68BAF69E6C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8454" y="936266"/>
            <a:ext cx="3560064" cy="439152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B594D18-AA87-B4D1-89A1-9093411AE0F7}"/>
              </a:ext>
            </a:extLst>
          </p:cNvPr>
          <p:cNvSpPr txBox="1"/>
          <p:nvPr/>
        </p:nvSpPr>
        <p:spPr>
          <a:xfrm>
            <a:off x="674056" y="5798870"/>
            <a:ext cx="814167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4. 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wo additional model realizations tested in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e study yielding similar results.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3D67BE5-5967-E468-C72C-3906794C5E3C}"/>
              </a:ext>
            </a:extLst>
          </p:cNvPr>
          <p:cNvSpPr txBox="1"/>
          <p:nvPr/>
        </p:nvSpPr>
        <p:spPr>
          <a:xfrm>
            <a:off x="456574" y="1222678"/>
            <a:ext cx="13529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igher rate module (</a:t>
            </a:r>
            <a:r>
              <a:rPr lang="en-US" dirty="0" err="1"/>
              <a:t>HRM</a:t>
            </a:r>
            <a:r>
              <a:rPr lang="en-US" dirty="0"/>
              <a:t>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4BF5703-3564-8002-2DFD-34F399ECD76C}"/>
              </a:ext>
            </a:extLst>
          </p:cNvPr>
          <p:cNvSpPr txBox="1"/>
          <p:nvPr/>
        </p:nvSpPr>
        <p:spPr>
          <a:xfrm>
            <a:off x="514109" y="3642791"/>
            <a:ext cx="14823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ower rate module (</a:t>
            </a:r>
            <a:r>
              <a:rPr lang="en-US" dirty="0" err="1"/>
              <a:t>LRM</a:t>
            </a:r>
            <a:r>
              <a:rPr lang="en-US" dirty="0"/>
              <a:t>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5512786-9BD1-2BE7-768F-6FE69166A4CC}"/>
              </a:ext>
            </a:extLst>
          </p:cNvPr>
          <p:cNvSpPr txBox="1"/>
          <p:nvPr/>
        </p:nvSpPr>
        <p:spPr>
          <a:xfrm>
            <a:off x="2101536" y="205920"/>
            <a:ext cx="963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odel 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934EB33-AC21-BBDB-1EB8-C4B9F289383F}"/>
              </a:ext>
            </a:extLst>
          </p:cNvPr>
          <p:cNvSpPr txBox="1"/>
          <p:nvPr/>
        </p:nvSpPr>
        <p:spPr>
          <a:xfrm>
            <a:off x="6116623" y="161995"/>
            <a:ext cx="963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odel 3</a:t>
            </a:r>
          </a:p>
        </p:txBody>
      </p:sp>
    </p:spTree>
    <p:extLst>
      <p:ext uri="{BB962C8B-B14F-4D97-AF65-F5344CB8AC3E}">
        <p14:creationId xmlns:p14="http://schemas.microsoft.com/office/powerpoint/2010/main" val="38293096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B594D18-AA87-B4D1-89A1-9093411AE0F7}"/>
              </a:ext>
            </a:extLst>
          </p:cNvPr>
          <p:cNvSpPr txBox="1"/>
          <p:nvPr/>
        </p:nvSpPr>
        <p:spPr>
          <a:xfrm>
            <a:off x="674056" y="5798870"/>
            <a:ext cx="8141677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5. 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 example of SAN network model consisting of 4 modules generated by our new computer algorithm available at GitHub 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2"/>
              </a:rPr>
              <a:t>https://github.com/alexmaltsev/IterativeNetworkGenerator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at can be used in the future studies of SAN function.</a:t>
            </a:r>
            <a:endParaRPr lang="en-US" sz="14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8DDE9641-8F58-8445-3C2D-79DC86357E1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402" y="546408"/>
            <a:ext cx="5455759" cy="47894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56615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85681A15-4759-460B-8812-EDAABCF1C3F9}" vid="{52AD63C0-794A-45BE-B74C-DA043E10E0C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257</TotalTime>
  <Words>807</Words>
  <Application>Microsoft Office PowerPoint</Application>
  <PresentationFormat>On-screen Show (4:3)</PresentationFormat>
  <Paragraphs>43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ackager Shell Objec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ltsev, Victor (NIH/NIA/IRP) [E]</dc:creator>
  <cp:lastModifiedBy>Maltsev, Victor (NIH/NIA/IRP) [E]</cp:lastModifiedBy>
  <cp:revision>33</cp:revision>
  <dcterms:created xsi:type="dcterms:W3CDTF">2023-07-15T20:49:27Z</dcterms:created>
  <dcterms:modified xsi:type="dcterms:W3CDTF">2023-11-16T13:36:35Z</dcterms:modified>
</cp:coreProperties>
</file>